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708" r:id="rId1"/>
  </p:sldMasterIdLst>
  <p:notesMasterIdLst>
    <p:notesMasterId r:id="rId3"/>
  </p:notesMasterIdLst>
  <p:sldIdLst>
    <p:sldId id="318" r:id="rId2"/>
  </p:sldIdLst>
  <p:sldSz cx="13320713" cy="10801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52" userDrawn="1">
          <p15:clr>
            <a:srgbClr val="A4A3A4"/>
          </p15:clr>
        </p15:guide>
        <p15:guide id="2" orient="horz" pos="3379" userDrawn="1">
          <p15:clr>
            <a:srgbClr val="A4A3A4"/>
          </p15:clr>
        </p15:guide>
        <p15:guide id="3" pos="5595" userDrawn="1">
          <p15:clr>
            <a:srgbClr val="A4A3A4"/>
          </p15:clr>
        </p15:guide>
        <p15:guide id="4" pos="433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叶 雪梅" initials="叶" lastIdx="3" clrIdx="0">
    <p:extLst>
      <p:ext uri="{19B8F6BF-5375-455C-9EA6-DF929625EA0E}">
        <p15:presenceInfo xmlns:p15="http://schemas.microsoft.com/office/powerpoint/2012/main" userId="0feb727a5510bc6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5427"/>
    <a:srgbClr val="00C95E"/>
    <a:srgbClr val="7030A0"/>
    <a:srgbClr val="0000FF"/>
    <a:srgbClr val="FF33CC"/>
    <a:srgbClr val="FC726C"/>
    <a:srgbClr val="3333FF"/>
    <a:srgbClr val="E46D0A"/>
    <a:srgbClr val="CCFF33"/>
    <a:srgbClr val="2E827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51" autoAdjust="0"/>
    <p:restoredTop sz="97668" autoAdjust="0"/>
  </p:normalViewPr>
  <p:slideViewPr>
    <p:cSldViewPr>
      <p:cViewPr>
        <p:scale>
          <a:sx n="100" d="100"/>
          <a:sy n="100" d="100"/>
        </p:scale>
        <p:origin x="-216" y="-1469"/>
      </p:cViewPr>
      <p:guideLst>
        <p:guide orient="horz" pos="2552"/>
        <p:guide orient="horz" pos="3379"/>
        <p:guide pos="5595"/>
        <p:guide pos="4336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8B7934-86AC-4FAF-8816-D9EAB701DE84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14450" y="685800"/>
            <a:ext cx="42291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174012-3FCF-423D-89AD-F8EDE1F7B7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8597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51117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102235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53352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204470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55587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306705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57822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408940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174012-3FCF-423D-89AD-F8EDE1F7B7A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96401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9054" y="1767722"/>
            <a:ext cx="11322606" cy="3760470"/>
          </a:xfrm>
        </p:spPr>
        <p:txBody>
          <a:bodyPr anchor="b"/>
          <a:lstStyle>
            <a:lvl1pPr algn="ctr">
              <a:defRPr sz="874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5673210"/>
            <a:ext cx="9990535" cy="2607825"/>
          </a:xfrm>
        </p:spPr>
        <p:txBody>
          <a:bodyPr/>
          <a:lstStyle>
            <a:lvl1pPr marL="0" indent="0" algn="ctr">
              <a:buNone/>
              <a:defRPr sz="3496"/>
            </a:lvl1pPr>
            <a:lvl2pPr marL="666049" indent="0" algn="ctr">
              <a:buNone/>
              <a:defRPr sz="2914"/>
            </a:lvl2pPr>
            <a:lvl3pPr marL="1332098" indent="0" algn="ctr">
              <a:buNone/>
              <a:defRPr sz="2622"/>
            </a:lvl3pPr>
            <a:lvl4pPr marL="1998147" indent="0" algn="ctr">
              <a:buNone/>
              <a:defRPr sz="2331"/>
            </a:lvl4pPr>
            <a:lvl5pPr marL="2664196" indent="0" algn="ctr">
              <a:buNone/>
              <a:defRPr sz="2331"/>
            </a:lvl5pPr>
            <a:lvl6pPr marL="3330245" indent="0" algn="ctr">
              <a:buNone/>
              <a:defRPr sz="2331"/>
            </a:lvl6pPr>
            <a:lvl7pPr marL="3996294" indent="0" algn="ctr">
              <a:buNone/>
              <a:defRPr sz="2331"/>
            </a:lvl7pPr>
            <a:lvl8pPr marL="4662343" indent="0" algn="ctr">
              <a:buNone/>
              <a:defRPr sz="2331"/>
            </a:lvl8pPr>
            <a:lvl9pPr marL="5328392" indent="0" algn="ctr">
              <a:buNone/>
              <a:defRPr sz="233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734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2664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6" y="575072"/>
            <a:ext cx="2872279" cy="915364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800" y="575072"/>
            <a:ext cx="8450327" cy="915364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8669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6490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2" y="2692840"/>
            <a:ext cx="11489115" cy="4493061"/>
          </a:xfrm>
        </p:spPr>
        <p:txBody>
          <a:bodyPr anchor="b"/>
          <a:lstStyle>
            <a:lvl1pPr>
              <a:defRPr sz="874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2" y="7228406"/>
            <a:ext cx="11489115" cy="2362795"/>
          </a:xfrm>
        </p:spPr>
        <p:txBody>
          <a:bodyPr/>
          <a:lstStyle>
            <a:lvl1pPr marL="0" indent="0">
              <a:buNone/>
              <a:defRPr sz="3496">
                <a:solidFill>
                  <a:schemeClr val="tx1"/>
                </a:solidFill>
              </a:defRPr>
            </a:lvl1pPr>
            <a:lvl2pPr marL="666049" indent="0">
              <a:buNone/>
              <a:defRPr sz="2914">
                <a:solidFill>
                  <a:schemeClr val="tx1">
                    <a:tint val="75000"/>
                  </a:schemeClr>
                </a:solidFill>
              </a:defRPr>
            </a:lvl2pPr>
            <a:lvl3pPr marL="1332098" indent="0">
              <a:buNone/>
              <a:defRPr sz="2622">
                <a:solidFill>
                  <a:schemeClr val="tx1">
                    <a:tint val="75000"/>
                  </a:schemeClr>
                </a:solidFill>
              </a:defRPr>
            </a:lvl3pPr>
            <a:lvl4pPr marL="1998147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4pPr>
            <a:lvl5pPr marL="2664196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5pPr>
            <a:lvl6pPr marL="3330245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6pPr>
            <a:lvl7pPr marL="3996294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7pPr>
            <a:lvl8pPr marL="4662343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8pPr>
            <a:lvl9pPr marL="5328392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8679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2875360"/>
            <a:ext cx="5661303" cy="68533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2875360"/>
            <a:ext cx="5661303" cy="68533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8615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575074"/>
            <a:ext cx="11489115" cy="20877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6" y="2647832"/>
            <a:ext cx="5635285" cy="1297661"/>
          </a:xfrm>
        </p:spPr>
        <p:txBody>
          <a:bodyPr anchor="b"/>
          <a:lstStyle>
            <a:lvl1pPr marL="0" indent="0">
              <a:buNone/>
              <a:defRPr sz="3496" b="1"/>
            </a:lvl1pPr>
            <a:lvl2pPr marL="666049" indent="0">
              <a:buNone/>
              <a:defRPr sz="2914" b="1"/>
            </a:lvl2pPr>
            <a:lvl3pPr marL="1332098" indent="0">
              <a:buNone/>
              <a:defRPr sz="2622" b="1"/>
            </a:lvl3pPr>
            <a:lvl4pPr marL="1998147" indent="0">
              <a:buNone/>
              <a:defRPr sz="2331" b="1"/>
            </a:lvl4pPr>
            <a:lvl5pPr marL="2664196" indent="0">
              <a:buNone/>
              <a:defRPr sz="2331" b="1"/>
            </a:lvl5pPr>
            <a:lvl6pPr marL="3330245" indent="0">
              <a:buNone/>
              <a:defRPr sz="2331" b="1"/>
            </a:lvl6pPr>
            <a:lvl7pPr marL="3996294" indent="0">
              <a:buNone/>
              <a:defRPr sz="2331" b="1"/>
            </a:lvl7pPr>
            <a:lvl8pPr marL="4662343" indent="0">
              <a:buNone/>
              <a:defRPr sz="2331" b="1"/>
            </a:lvl8pPr>
            <a:lvl9pPr marL="5328392" indent="0">
              <a:buNone/>
              <a:defRPr sz="233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6" y="3945493"/>
            <a:ext cx="5635285" cy="580322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2" y="2647832"/>
            <a:ext cx="5663038" cy="1297661"/>
          </a:xfrm>
        </p:spPr>
        <p:txBody>
          <a:bodyPr anchor="b"/>
          <a:lstStyle>
            <a:lvl1pPr marL="0" indent="0">
              <a:buNone/>
              <a:defRPr sz="3496" b="1"/>
            </a:lvl1pPr>
            <a:lvl2pPr marL="666049" indent="0">
              <a:buNone/>
              <a:defRPr sz="2914" b="1"/>
            </a:lvl2pPr>
            <a:lvl3pPr marL="1332098" indent="0">
              <a:buNone/>
              <a:defRPr sz="2622" b="1"/>
            </a:lvl3pPr>
            <a:lvl4pPr marL="1998147" indent="0">
              <a:buNone/>
              <a:defRPr sz="2331" b="1"/>
            </a:lvl4pPr>
            <a:lvl5pPr marL="2664196" indent="0">
              <a:buNone/>
              <a:defRPr sz="2331" b="1"/>
            </a:lvl5pPr>
            <a:lvl6pPr marL="3330245" indent="0">
              <a:buNone/>
              <a:defRPr sz="2331" b="1"/>
            </a:lvl6pPr>
            <a:lvl7pPr marL="3996294" indent="0">
              <a:buNone/>
              <a:defRPr sz="2331" b="1"/>
            </a:lvl7pPr>
            <a:lvl8pPr marL="4662343" indent="0">
              <a:buNone/>
              <a:defRPr sz="2331" b="1"/>
            </a:lvl8pPr>
            <a:lvl9pPr marL="5328392" indent="0">
              <a:buNone/>
              <a:defRPr sz="233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2" y="3945493"/>
            <a:ext cx="5663038" cy="580322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792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1430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8323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720090"/>
            <a:ext cx="4296277" cy="2520315"/>
          </a:xfrm>
        </p:spPr>
        <p:txBody>
          <a:bodyPr anchor="b"/>
          <a:lstStyle>
            <a:lvl1pPr>
              <a:defRPr sz="466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1555197"/>
            <a:ext cx="6743611" cy="7675959"/>
          </a:xfrm>
        </p:spPr>
        <p:txBody>
          <a:bodyPr/>
          <a:lstStyle>
            <a:lvl1pPr>
              <a:defRPr sz="4662"/>
            </a:lvl1pPr>
            <a:lvl2pPr>
              <a:defRPr sz="4079"/>
            </a:lvl2pPr>
            <a:lvl3pPr>
              <a:defRPr sz="3496"/>
            </a:lvl3pPr>
            <a:lvl4pPr>
              <a:defRPr sz="2914"/>
            </a:lvl4pPr>
            <a:lvl5pPr>
              <a:defRPr sz="2914"/>
            </a:lvl5pPr>
            <a:lvl6pPr>
              <a:defRPr sz="2914"/>
            </a:lvl6pPr>
            <a:lvl7pPr>
              <a:defRPr sz="2914"/>
            </a:lvl7pPr>
            <a:lvl8pPr>
              <a:defRPr sz="2914"/>
            </a:lvl8pPr>
            <a:lvl9pPr>
              <a:defRPr sz="291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3240405"/>
            <a:ext cx="4296277" cy="6003251"/>
          </a:xfrm>
        </p:spPr>
        <p:txBody>
          <a:bodyPr/>
          <a:lstStyle>
            <a:lvl1pPr marL="0" indent="0">
              <a:buNone/>
              <a:defRPr sz="2331"/>
            </a:lvl1pPr>
            <a:lvl2pPr marL="666049" indent="0">
              <a:buNone/>
              <a:defRPr sz="2040"/>
            </a:lvl2pPr>
            <a:lvl3pPr marL="1332098" indent="0">
              <a:buNone/>
              <a:defRPr sz="1748"/>
            </a:lvl3pPr>
            <a:lvl4pPr marL="1998147" indent="0">
              <a:buNone/>
              <a:defRPr sz="1457"/>
            </a:lvl4pPr>
            <a:lvl5pPr marL="2664196" indent="0">
              <a:buNone/>
              <a:defRPr sz="1457"/>
            </a:lvl5pPr>
            <a:lvl6pPr marL="3330245" indent="0">
              <a:buNone/>
              <a:defRPr sz="1457"/>
            </a:lvl6pPr>
            <a:lvl7pPr marL="3996294" indent="0">
              <a:buNone/>
              <a:defRPr sz="1457"/>
            </a:lvl7pPr>
            <a:lvl8pPr marL="4662343" indent="0">
              <a:buNone/>
              <a:defRPr sz="1457"/>
            </a:lvl8pPr>
            <a:lvl9pPr marL="5328392" indent="0">
              <a:buNone/>
              <a:defRPr sz="145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3810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720090"/>
            <a:ext cx="4296277" cy="2520315"/>
          </a:xfrm>
        </p:spPr>
        <p:txBody>
          <a:bodyPr anchor="b"/>
          <a:lstStyle>
            <a:lvl1pPr>
              <a:defRPr sz="466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1555197"/>
            <a:ext cx="6743611" cy="7675959"/>
          </a:xfrm>
        </p:spPr>
        <p:txBody>
          <a:bodyPr anchor="t"/>
          <a:lstStyle>
            <a:lvl1pPr marL="0" indent="0">
              <a:buNone/>
              <a:defRPr sz="4662"/>
            </a:lvl1pPr>
            <a:lvl2pPr marL="666049" indent="0">
              <a:buNone/>
              <a:defRPr sz="4079"/>
            </a:lvl2pPr>
            <a:lvl3pPr marL="1332098" indent="0">
              <a:buNone/>
              <a:defRPr sz="3496"/>
            </a:lvl3pPr>
            <a:lvl4pPr marL="1998147" indent="0">
              <a:buNone/>
              <a:defRPr sz="2914"/>
            </a:lvl4pPr>
            <a:lvl5pPr marL="2664196" indent="0">
              <a:buNone/>
              <a:defRPr sz="2914"/>
            </a:lvl5pPr>
            <a:lvl6pPr marL="3330245" indent="0">
              <a:buNone/>
              <a:defRPr sz="2914"/>
            </a:lvl6pPr>
            <a:lvl7pPr marL="3996294" indent="0">
              <a:buNone/>
              <a:defRPr sz="2914"/>
            </a:lvl7pPr>
            <a:lvl8pPr marL="4662343" indent="0">
              <a:buNone/>
              <a:defRPr sz="2914"/>
            </a:lvl8pPr>
            <a:lvl9pPr marL="5328392" indent="0">
              <a:buNone/>
              <a:defRPr sz="291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3240405"/>
            <a:ext cx="4296277" cy="6003251"/>
          </a:xfrm>
        </p:spPr>
        <p:txBody>
          <a:bodyPr/>
          <a:lstStyle>
            <a:lvl1pPr marL="0" indent="0">
              <a:buNone/>
              <a:defRPr sz="2331"/>
            </a:lvl1pPr>
            <a:lvl2pPr marL="666049" indent="0">
              <a:buNone/>
              <a:defRPr sz="2040"/>
            </a:lvl2pPr>
            <a:lvl3pPr marL="1332098" indent="0">
              <a:buNone/>
              <a:defRPr sz="1748"/>
            </a:lvl3pPr>
            <a:lvl4pPr marL="1998147" indent="0">
              <a:buNone/>
              <a:defRPr sz="1457"/>
            </a:lvl4pPr>
            <a:lvl5pPr marL="2664196" indent="0">
              <a:buNone/>
              <a:defRPr sz="1457"/>
            </a:lvl5pPr>
            <a:lvl6pPr marL="3330245" indent="0">
              <a:buNone/>
              <a:defRPr sz="1457"/>
            </a:lvl6pPr>
            <a:lvl7pPr marL="3996294" indent="0">
              <a:buNone/>
              <a:defRPr sz="1457"/>
            </a:lvl7pPr>
            <a:lvl8pPr marL="4662343" indent="0">
              <a:buNone/>
              <a:defRPr sz="1457"/>
            </a:lvl8pPr>
            <a:lvl9pPr marL="5328392" indent="0">
              <a:buNone/>
              <a:defRPr sz="145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832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575074"/>
            <a:ext cx="11489115" cy="2087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2875360"/>
            <a:ext cx="11489115" cy="68533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10011254"/>
            <a:ext cx="299716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10011254"/>
            <a:ext cx="4495741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10011254"/>
            <a:ext cx="299716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7596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332098" rtl="0" eaLnBrk="1" latinLnBrk="0" hangingPunct="1">
        <a:lnSpc>
          <a:spcPct val="90000"/>
        </a:lnSpc>
        <a:spcBef>
          <a:spcPct val="0"/>
        </a:spcBef>
        <a:buNone/>
        <a:defRPr sz="64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3024" indent="-333024" algn="l" defTabSz="1332098" rtl="0" eaLnBrk="1" latinLnBrk="0" hangingPunct="1">
        <a:lnSpc>
          <a:spcPct val="90000"/>
        </a:lnSpc>
        <a:spcBef>
          <a:spcPts val="1457"/>
        </a:spcBef>
        <a:buFont typeface="Arial" panose="020B0604020202020204" pitchFamily="34" charset="0"/>
        <a:buChar char="•"/>
        <a:defRPr sz="4079" kern="1200">
          <a:solidFill>
            <a:schemeClr val="tx1"/>
          </a:solidFill>
          <a:latin typeface="+mn-lt"/>
          <a:ea typeface="+mn-ea"/>
          <a:cs typeface="+mn-cs"/>
        </a:defRPr>
      </a:lvl1pPr>
      <a:lvl2pPr marL="999073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3496" kern="1200">
          <a:solidFill>
            <a:schemeClr val="tx1"/>
          </a:solidFill>
          <a:latin typeface="+mn-lt"/>
          <a:ea typeface="+mn-ea"/>
          <a:cs typeface="+mn-cs"/>
        </a:defRPr>
      </a:lvl2pPr>
      <a:lvl3pPr marL="1665122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914" kern="1200">
          <a:solidFill>
            <a:schemeClr val="tx1"/>
          </a:solidFill>
          <a:latin typeface="+mn-lt"/>
          <a:ea typeface="+mn-ea"/>
          <a:cs typeface="+mn-cs"/>
        </a:defRPr>
      </a:lvl3pPr>
      <a:lvl4pPr marL="2331171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4pPr>
      <a:lvl5pPr marL="2997220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5pPr>
      <a:lvl6pPr marL="3663269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6pPr>
      <a:lvl7pPr marL="4329318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7pPr>
      <a:lvl8pPr marL="4995367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8pPr>
      <a:lvl9pPr marL="5661416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1pPr>
      <a:lvl2pPr marL="666049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2pPr>
      <a:lvl3pPr marL="1332098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3pPr>
      <a:lvl4pPr marL="1998147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4pPr>
      <a:lvl5pPr marL="2664196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5pPr>
      <a:lvl6pPr marL="3330245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6pPr>
      <a:lvl7pPr marL="3996294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7pPr>
      <a:lvl8pPr marL="4662343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8pPr>
      <a:lvl9pPr marL="5328392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" Type="http://schemas.openxmlformats.org/officeDocument/2006/relationships/image" Target="../media/image1.png"/><Relationship Id="rId21" Type="http://schemas.openxmlformats.org/officeDocument/2006/relationships/image" Target="../media/image10.png"/><Relationship Id="rId34" Type="http://schemas.microsoft.com/office/2007/relationships/hdphoto" Target="../media/hdphoto16.wdp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33" Type="http://schemas.openxmlformats.org/officeDocument/2006/relationships/image" Target="../media/image16.png"/><Relationship Id="rId38" Type="http://schemas.microsoft.com/office/2007/relationships/hdphoto" Target="../media/hdphoto18.wdp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18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28" Type="http://schemas.microsoft.com/office/2007/relationships/hdphoto" Target="../media/hdphoto13.wdp"/><Relationship Id="rId36" Type="http://schemas.microsoft.com/office/2007/relationships/hdphoto" Target="../media/hdphoto17.wdp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31" Type="http://schemas.openxmlformats.org/officeDocument/2006/relationships/image" Target="../media/image15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3.png"/><Relationship Id="rId30" Type="http://schemas.microsoft.com/office/2007/relationships/hdphoto" Target="../media/hdphoto14.wdp"/><Relationship Id="rId35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9">
            <a:extLst>
              <a:ext uri="{FF2B5EF4-FFF2-40B4-BE49-F238E27FC236}">
                <a16:creationId xmlns:a16="http://schemas.microsoft.com/office/drawing/2014/main" xmlns="" id="{CF64B827-8977-4C46-8D24-275374E7228D}"/>
              </a:ext>
            </a:extLst>
          </p:cNvPr>
          <p:cNvSpPr txBox="1"/>
          <p:nvPr/>
        </p:nvSpPr>
        <p:spPr>
          <a:xfrm>
            <a:off x="945635" y="1412134"/>
            <a:ext cx="1251980" cy="441791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Pid3-F/N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charset="0"/>
              </a:rPr>
              <a:t>C2209T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(216/145 bp)</a:t>
            </a:r>
          </a:p>
        </p:txBody>
      </p:sp>
      <p:sp>
        <p:nvSpPr>
          <p:cNvPr id="5" name="TextBox 13">
            <a:extLst>
              <a:ext uri="{FF2B5EF4-FFF2-40B4-BE49-F238E27FC236}">
                <a16:creationId xmlns:a16="http://schemas.microsoft.com/office/drawing/2014/main" xmlns="" id="{8693F25F-E814-4A5B-9BCD-A2BF22B1A166}"/>
              </a:ext>
            </a:extLst>
          </p:cNvPr>
          <p:cNvSpPr txBox="1"/>
          <p:nvPr/>
        </p:nvSpPr>
        <p:spPr>
          <a:xfrm>
            <a:off x="1013979" y="1008187"/>
            <a:ext cx="1188395" cy="440055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Pid3-F/N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charset="0"/>
              </a:rPr>
              <a:t>G2009A</a:t>
            </a:r>
          </a:p>
          <a:p>
            <a:pPr algn="r"/>
            <a:r>
              <a:rPr lang="en-US" altLang="zh-CN" sz="1100">
                <a:latin typeface="Palatino Linotype" panose="02040502050505030304" pitchFamily="18" charset="0"/>
                <a:cs typeface="Times New Roman" panose="02020603050405020304" charset="0"/>
              </a:rPr>
              <a:t>(138/104 </a:t>
            </a:r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bp)</a:t>
            </a:r>
          </a:p>
        </p:txBody>
      </p:sp>
      <p:sp>
        <p:nvSpPr>
          <p:cNvPr id="7" name="TextBox 16">
            <a:extLst>
              <a:ext uri="{FF2B5EF4-FFF2-40B4-BE49-F238E27FC236}">
                <a16:creationId xmlns:a16="http://schemas.microsoft.com/office/drawing/2014/main" xmlns="" id="{3037489E-25BF-4D62-9508-E09B265DC372}"/>
              </a:ext>
            </a:extLst>
          </p:cNvPr>
          <p:cNvSpPr txBox="1"/>
          <p:nvPr/>
        </p:nvSpPr>
        <p:spPr>
          <a:xfrm>
            <a:off x="880966" y="2008292"/>
            <a:ext cx="1328639" cy="440055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Pid3-DIG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charset="0"/>
              </a:rPr>
              <a:t>G775A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(138/102 </a:t>
            </a:r>
            <a:r>
              <a:rPr lang="en-US" altLang="zh-CN" sz="1100" dirty="0" err="1">
                <a:latin typeface="Palatino Linotype" panose="02040502050505030304" pitchFamily="18" charset="0"/>
                <a:cs typeface="Times New Roman" panose="02020603050405020304" charset="0"/>
              </a:rPr>
              <a:t>bp</a:t>
            </a:r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)</a:t>
            </a:r>
          </a:p>
        </p:txBody>
      </p:sp>
      <p:sp>
        <p:nvSpPr>
          <p:cNvPr id="9" name="TextBox 16">
            <a:extLst>
              <a:ext uri="{FF2B5EF4-FFF2-40B4-BE49-F238E27FC236}">
                <a16:creationId xmlns:a16="http://schemas.microsoft.com/office/drawing/2014/main" xmlns="" id="{7FB6A90B-8138-4915-A5CC-F1541AC1BAB0}"/>
              </a:ext>
            </a:extLst>
          </p:cNvPr>
          <p:cNvSpPr txBox="1"/>
          <p:nvPr/>
        </p:nvSpPr>
        <p:spPr>
          <a:xfrm>
            <a:off x="883967" y="2397473"/>
            <a:ext cx="1328639" cy="440055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Pid3-DIG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charset="0"/>
              </a:rPr>
              <a:t>G2695A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(148/121 bp)</a:t>
            </a:r>
          </a:p>
        </p:txBody>
      </p:sp>
      <p:sp>
        <p:nvSpPr>
          <p:cNvPr id="11" name="TextBox 16">
            <a:extLst>
              <a:ext uri="{FF2B5EF4-FFF2-40B4-BE49-F238E27FC236}">
                <a16:creationId xmlns:a16="http://schemas.microsoft.com/office/drawing/2014/main" xmlns="" id="{845F4115-231A-4897-940F-E04236E25B03}"/>
              </a:ext>
            </a:extLst>
          </p:cNvPr>
          <p:cNvSpPr txBox="1"/>
          <p:nvPr/>
        </p:nvSpPr>
        <p:spPr>
          <a:xfrm>
            <a:off x="683693" y="3014668"/>
            <a:ext cx="1517445" cy="441791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Pid3-TTP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charset="0"/>
              </a:rPr>
              <a:t>C1136T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(110/85 bp)</a:t>
            </a:r>
          </a:p>
        </p:txBody>
      </p:sp>
      <p:sp>
        <p:nvSpPr>
          <p:cNvPr id="13" name="TextBox 16">
            <a:extLst>
              <a:ext uri="{FF2B5EF4-FFF2-40B4-BE49-F238E27FC236}">
                <a16:creationId xmlns:a16="http://schemas.microsoft.com/office/drawing/2014/main" xmlns="" id="{9A7F2B4C-188D-4536-A382-809EA9594777}"/>
              </a:ext>
            </a:extLst>
          </p:cNvPr>
          <p:cNvSpPr txBox="1"/>
          <p:nvPr/>
        </p:nvSpPr>
        <p:spPr>
          <a:xfrm>
            <a:off x="683693" y="4032523"/>
            <a:ext cx="1517445" cy="441791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Pid3-ZS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charset="0"/>
              </a:rPr>
              <a:t>G477A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(145/125 bp)</a:t>
            </a:r>
          </a:p>
        </p:txBody>
      </p:sp>
      <p:sp>
        <p:nvSpPr>
          <p:cNvPr id="15" name="TextBox 16">
            <a:extLst>
              <a:ext uri="{FF2B5EF4-FFF2-40B4-BE49-F238E27FC236}">
                <a16:creationId xmlns:a16="http://schemas.microsoft.com/office/drawing/2014/main" xmlns="" id="{2C805527-7462-45D4-98DA-D0EB3FFC4268}"/>
              </a:ext>
            </a:extLst>
          </p:cNvPr>
          <p:cNvSpPr txBox="1"/>
          <p:nvPr/>
        </p:nvSpPr>
        <p:spPr>
          <a:xfrm>
            <a:off x="875500" y="4431420"/>
            <a:ext cx="1328639" cy="440055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>
                <a:latin typeface="Palatino Linotype" panose="02040502050505030304" pitchFamily="18" charset="0"/>
                <a:cs typeface="Times New Roman" panose="02020603050405020304" charset="0"/>
              </a:rPr>
              <a:t>Pid3-ZS</a:t>
            </a:r>
            <a:r>
              <a:rPr lang="en-US" altLang="zh-CN" sz="1100" baseline="30000">
                <a:latin typeface="Palatino Linotype" panose="02040502050505030304" pitchFamily="18" charset="0"/>
                <a:cs typeface="Times New Roman" panose="02020603050405020304" charset="0"/>
              </a:rPr>
              <a:t>C525T</a:t>
            </a:r>
            <a:endParaRPr lang="en-US" altLang="zh-CN" sz="1100" dirty="0">
              <a:latin typeface="Palatino Linotype" panose="02040502050505030304" pitchFamily="18" charset="0"/>
              <a:cs typeface="Times New Roman" panose="02020603050405020304" charset="0"/>
            </a:endParaRPr>
          </a:p>
          <a:p>
            <a:pPr algn="r"/>
            <a:r>
              <a:rPr lang="en-US" altLang="zh-CN" sz="1100">
                <a:latin typeface="Palatino Linotype" panose="02040502050505030304" pitchFamily="18" charset="0"/>
                <a:cs typeface="Times New Roman" panose="02020603050405020304" charset="0"/>
              </a:rPr>
              <a:t>(125/104 </a:t>
            </a:r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bp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6A5836DA-BB56-495D-9723-9F3B5867CD4B}"/>
              </a:ext>
            </a:extLst>
          </p:cNvPr>
          <p:cNvSpPr txBox="1"/>
          <p:nvPr/>
        </p:nvSpPr>
        <p:spPr>
          <a:xfrm>
            <a:off x="671697" y="3416728"/>
            <a:ext cx="1517445" cy="441791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Pid3-TTP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charset="0"/>
              </a:rPr>
              <a:t>C1623G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(120/102 bp)</a:t>
            </a:r>
          </a:p>
        </p:txBody>
      </p:sp>
      <p:graphicFrame>
        <p:nvGraphicFramePr>
          <p:cNvPr id="19" name="表格 18">
            <a:extLst>
              <a:ext uri="{FF2B5EF4-FFF2-40B4-BE49-F238E27FC236}">
                <a16:creationId xmlns:a16="http://schemas.microsoft.com/office/drawing/2014/main" xmlns="" id="{5B733C43-9E0D-4D97-97D7-3661A3BE3B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1029869"/>
              </p:ext>
            </p:extLst>
          </p:nvPr>
        </p:nvGraphicFramePr>
        <p:xfrm>
          <a:off x="2168742" y="288107"/>
          <a:ext cx="10316501" cy="67296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5154">
                  <a:extLst>
                    <a:ext uri="{9D8B030D-6E8A-4147-A177-3AD203B41FA5}">
                      <a16:colId xmlns:a16="http://schemas.microsoft.com/office/drawing/2014/main" xmlns="" val="214352295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55330355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33445769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4860373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89179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189179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189179">
                  <a:extLst>
                    <a:ext uri="{9D8B030D-6E8A-4147-A177-3AD203B41FA5}">
                      <a16:colId xmlns:a16="http://schemas.microsoft.com/office/drawing/2014/main" xmlns="" val="2001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578323557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140757916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524379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350323105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29563709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366780416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30758323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51137064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311746790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64242010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38295204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960260079"/>
                    </a:ext>
                  </a:extLst>
                </a:gridCol>
              </a:tblGrid>
              <a:tr h="6729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6</a:t>
                      </a:r>
                      <a:endParaRPr lang="en-US" sz="1200" b="0" i="0" u="none" strike="noStrike" dirty="0">
                        <a:solidFill>
                          <a:srgbClr val="005427"/>
                        </a:solidFill>
                        <a:effectLst/>
                        <a:latin typeface="Palatino Linotype" panose="02040502050505030304" pitchFamily="18" charset="0"/>
                        <a:cs typeface="Times New Roman" pitchFamily="18" charset="0"/>
                      </a:endParaRP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7030A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21" name="TextBox 27">
            <a:extLst>
              <a:ext uri="{FF2B5EF4-FFF2-40B4-BE49-F238E27FC236}">
                <a16:creationId xmlns:a16="http://schemas.microsoft.com/office/drawing/2014/main" xmlns="" id="{14BF1BBE-FE3D-4DC8-BFEB-D8A493536D4C}"/>
              </a:ext>
            </a:extLst>
          </p:cNvPr>
          <p:cNvSpPr txBox="1"/>
          <p:nvPr/>
        </p:nvSpPr>
        <p:spPr>
          <a:xfrm>
            <a:off x="1259756" y="6984851"/>
            <a:ext cx="113772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kern="100" smtClean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4. 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lele mining of the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id3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lleles in the additional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Xian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A to D) and </a:t>
            </a:r>
            <a:r>
              <a:rPr lang="en-US" altLang="zh-CN" sz="1200" i="1" kern="100" dirty="0" err="1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g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E) rice cultivar panels, in the former four </a:t>
            </a:r>
            <a:r>
              <a:rPr lang="en-US" altLang="zh-CN" sz="1200" kern="100" dirty="0" err="1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vs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which were repeated from the regular panel, were ruled out. 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CK1, Digu (</a:t>
            </a:r>
            <a:r>
              <a:rPr lang="en-US" altLang="zh-CN" sz="1200" i="1" kern="100" dirty="0">
                <a:latin typeface="Palatino Linotype" panose="02040502050505030304" pitchFamily="18" charset="0"/>
              </a:rPr>
              <a:t>Pid3-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DIG; red); CK2, Tetep (</a:t>
            </a:r>
            <a:r>
              <a:rPr lang="en-US" altLang="zh-CN" sz="1200" i="1" kern="100" dirty="0">
                <a:latin typeface="Palatino Linotype" panose="02040502050505030304" pitchFamily="18" charset="0"/>
              </a:rPr>
              <a:t>Pid3-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TTP; blue); CK3, </a:t>
            </a:r>
            <a:r>
              <a:rPr lang="en-US" altLang="zh-CN" sz="1200" kern="100" dirty="0" err="1">
                <a:latin typeface="Palatino Linotype" panose="02040502050505030304" pitchFamily="18" charset="0"/>
              </a:rPr>
              <a:t>Zhenshan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 97 (</a:t>
            </a:r>
            <a:r>
              <a:rPr lang="en-US" altLang="zh-CN" sz="1200" i="1" kern="100" dirty="0">
                <a:latin typeface="Palatino Linotype" panose="02040502050505030304" pitchFamily="18" charset="0"/>
              </a:rPr>
              <a:t>Pid3-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ZS; green); CK4, Nipponbare (</a:t>
            </a:r>
            <a:r>
              <a:rPr lang="en-US" altLang="zh-CN" sz="1200" i="1" kern="100" dirty="0">
                <a:latin typeface="Palatino Linotype" panose="02040502050505030304" pitchFamily="18" charset="0"/>
              </a:rPr>
              <a:t>Pid3-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Null; black); CK5, </a:t>
            </a:r>
            <a:r>
              <a:rPr lang="en-US" altLang="zh-CN" sz="1200" kern="100" dirty="0" err="1">
                <a:latin typeface="Palatino Linotype" panose="02040502050505030304" pitchFamily="18" charset="0"/>
              </a:rPr>
              <a:t>Shennong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 265 (</a:t>
            </a:r>
            <a:r>
              <a:rPr lang="en-US" altLang="zh-CN" sz="1200" i="1" kern="100" dirty="0">
                <a:latin typeface="Palatino Linotype" panose="02040502050505030304" pitchFamily="18" charset="0"/>
              </a:rPr>
              <a:t>Pid3-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Null; black); CK6, CO39 (</a:t>
            </a:r>
            <a:r>
              <a:rPr lang="en-US" altLang="zh-CN" sz="1200" i="1" kern="100" dirty="0">
                <a:latin typeface="Palatino Linotype" panose="02040502050505030304" pitchFamily="18" charset="0"/>
              </a:rPr>
              <a:t>Pid3-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ZS; green); and undefined allele carried by CV86 was marked in purple. M: DL-500 size marker.</a:t>
            </a: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xmlns="" id="{431D5CD4-86F4-446D-8035-753A6F6B68E2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bright="8000" contrast="-51000"/>
                    </a14:imgEffect>
                  </a14:imgLayer>
                </a14:imgProps>
              </a:ext>
            </a:extLst>
          </a:blip>
          <a:srcRect t="3668" r="3744"/>
          <a:stretch/>
        </p:blipFill>
        <p:spPr>
          <a:xfrm>
            <a:off x="2191948" y="1030214"/>
            <a:ext cx="5245200" cy="3600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xmlns="" id="{18A886A5-6B75-4B9F-A317-10843A305661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bright="-6000" contrast="-16000"/>
                    </a14:imgEffect>
                  </a14:imgLayer>
                </a14:imgProps>
              </a:ext>
            </a:extLst>
          </a:blip>
          <a:srcRect l="3744" t="-1" b="5150"/>
          <a:stretch/>
        </p:blipFill>
        <p:spPr>
          <a:xfrm>
            <a:off x="7457202" y="1030214"/>
            <a:ext cx="5032800" cy="36000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xmlns="" id="{BD16719A-44EF-4CE4-9B3F-D3BF8932E1CF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4039" t="3932" r="-1" b="1499"/>
          <a:stretch/>
        </p:blipFill>
        <p:spPr>
          <a:xfrm>
            <a:off x="7452443" y="1435029"/>
            <a:ext cx="5032800" cy="360000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xmlns="" id="{49D5AFEA-BE76-4CD6-91F4-EED54FC7D91B}"/>
              </a:ext>
            </a:extLst>
          </p:cNvPr>
          <p:cNvPicPr>
            <a:picLocks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bright="-10000" contrast="-38000"/>
                    </a14:imgEffect>
                  </a14:imgLayer>
                </a14:imgProps>
              </a:ext>
            </a:extLst>
          </a:blip>
          <a:srcRect l="4308" b="21409"/>
          <a:stretch/>
        </p:blipFill>
        <p:spPr>
          <a:xfrm>
            <a:off x="7460204" y="2419500"/>
            <a:ext cx="5032800" cy="36000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xmlns="" id="{EE885004-22F3-4095-8FE5-96976327253C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bright="4000" contrast="-48000"/>
                    </a14:imgEffect>
                  </a14:imgLayer>
                </a14:imgProps>
              </a:ext>
            </a:extLst>
          </a:blip>
          <a:srcRect t="988" r="4121"/>
          <a:stretch/>
        </p:blipFill>
        <p:spPr>
          <a:xfrm>
            <a:off x="2194950" y="2419500"/>
            <a:ext cx="5245200" cy="36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850FFE3A-4F15-4442-9354-96F72B0533A3}"/>
              </a:ext>
            </a:extLst>
          </p:cNvPr>
          <p:cNvPicPr>
            <a:picLocks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  <a14:imgEffect>
                      <a14:brightnessContrast bright="-6000" contrast="-49000"/>
                    </a14:imgEffect>
                  </a14:imgLayer>
                </a14:imgProps>
              </a:ext>
            </a:extLst>
          </a:blip>
          <a:srcRect l="3788"/>
          <a:stretch/>
        </p:blipFill>
        <p:spPr>
          <a:xfrm>
            <a:off x="7457202" y="4055418"/>
            <a:ext cx="5032800" cy="3600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DC8B8678-89AB-4D9E-9732-17EDB5AAB787}"/>
              </a:ext>
            </a:extLst>
          </p:cNvPr>
          <p:cNvPicPr>
            <a:picLocks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  <a14:imgEffect>
                      <a14:brightnessContrast bright="10000" contrast="-33000"/>
                    </a14:imgEffect>
                  </a14:imgLayer>
                </a14:imgProps>
              </a:ext>
            </a:extLst>
          </a:blip>
          <a:srcRect t="1449" r="3594"/>
          <a:stretch/>
        </p:blipFill>
        <p:spPr>
          <a:xfrm>
            <a:off x="2191948" y="4055418"/>
            <a:ext cx="5245200" cy="36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xmlns="" id="{247CF351-AE60-4623-AE09-87B9BF14ACC6}"/>
              </a:ext>
            </a:extLst>
          </p:cNvPr>
          <p:cNvPicPr>
            <a:picLocks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50000"/>
                    </a14:imgEffect>
                    <a14:imgEffect>
                      <a14:brightnessContrast bright="13000" contrast="-41000"/>
                    </a14:imgEffect>
                  </a14:imgLayer>
                </a14:imgProps>
              </a:ext>
            </a:extLst>
          </a:blip>
          <a:srcRect l="3479" t="4417" b="5918"/>
          <a:stretch/>
        </p:blipFill>
        <p:spPr>
          <a:xfrm>
            <a:off x="7457202" y="3037563"/>
            <a:ext cx="5032800" cy="36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xmlns="" id="{DF48EE97-9898-4FD8-B7E3-BD81675260D2}"/>
              </a:ext>
            </a:extLst>
          </p:cNvPr>
          <p:cNvPicPr>
            <a:picLocks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50000"/>
                    </a14:imgEffect>
                    <a14:imgEffect>
                      <a14:brightnessContrast bright="6000" contrast="-36000"/>
                    </a14:imgEffect>
                  </a14:imgLayer>
                </a14:imgProps>
              </a:ext>
            </a:extLst>
          </a:blip>
          <a:srcRect r="3777"/>
          <a:stretch/>
        </p:blipFill>
        <p:spPr>
          <a:xfrm>
            <a:off x="2191948" y="3037563"/>
            <a:ext cx="5245200" cy="360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xmlns="" id="{FB14BDDA-6C20-45D6-94E7-46AF435CDDAF}"/>
              </a:ext>
            </a:extLst>
          </p:cNvPr>
          <p:cNvPicPr>
            <a:picLocks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harpenSoften amount="50000"/>
                    </a14:imgEffect>
                    <a14:imgEffect>
                      <a14:brightnessContrast bright="6000" contrast="-41000"/>
                    </a14:imgEffect>
                  </a14:imgLayer>
                </a14:imgProps>
              </a:ext>
            </a:extLst>
          </a:blip>
          <a:srcRect t="30" r="3620" b="-1"/>
          <a:stretch/>
        </p:blipFill>
        <p:spPr>
          <a:xfrm>
            <a:off x="2189142" y="3439623"/>
            <a:ext cx="5245200" cy="360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xmlns="" id="{58748DFD-40B7-4D8E-A22C-A0B0409ECA78}"/>
              </a:ext>
            </a:extLst>
          </p:cNvPr>
          <p:cNvPicPr>
            <a:picLocks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harpenSoften amount="50000"/>
                    </a14:imgEffect>
                    <a14:imgEffect>
                      <a14:brightnessContrast bright="5000" contrast="-24000"/>
                    </a14:imgEffect>
                  </a14:imgLayer>
                </a14:imgProps>
              </a:ext>
            </a:extLst>
          </a:blip>
          <a:srcRect l="3748" b="1822"/>
          <a:stretch/>
        </p:blipFill>
        <p:spPr>
          <a:xfrm>
            <a:off x="7454396" y="3439623"/>
            <a:ext cx="5032800" cy="3600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xmlns="" id="{7636A5D9-F230-47B5-A467-29C031DE505D}"/>
              </a:ext>
            </a:extLst>
          </p:cNvPr>
          <p:cNvPicPr>
            <a:picLocks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harpenSoften amount="81000"/>
                    </a14:imgEffect>
                    <a14:imgEffect>
                      <a14:brightnessContrast bright="9000" contrast="-42000"/>
                    </a14:imgEffect>
                  </a14:imgLayer>
                </a14:imgProps>
              </a:ext>
            </a:extLst>
          </a:blip>
          <a:srcRect l="3528" t="1146" b="6249"/>
          <a:stretch/>
        </p:blipFill>
        <p:spPr>
          <a:xfrm>
            <a:off x="7460204" y="4453447"/>
            <a:ext cx="5032800" cy="36000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xmlns="" id="{9C8594C9-E7D6-4227-A8D3-F3B091FBC69F}"/>
              </a:ext>
            </a:extLst>
          </p:cNvPr>
          <p:cNvPicPr>
            <a:picLocks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r="3409"/>
          <a:stretch/>
        </p:blipFill>
        <p:spPr>
          <a:xfrm>
            <a:off x="2194950" y="4453447"/>
            <a:ext cx="5245200" cy="36000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xmlns="" id="{7F480084-82BC-4698-82D5-8F9B130F3904}"/>
              </a:ext>
            </a:extLst>
          </p:cNvPr>
          <p:cNvPicPr>
            <a:picLocks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sharpenSoften amount="50000"/>
                    </a14:imgEffect>
                    <a14:imgEffect>
                      <a14:brightnessContrast bright="8000" contrast="-47000"/>
                    </a14:imgEffect>
                  </a14:imgLayer>
                </a14:imgProps>
              </a:ext>
            </a:extLst>
          </a:blip>
          <a:srcRect t="32186" r="3794" b="11901"/>
          <a:stretch/>
        </p:blipFill>
        <p:spPr>
          <a:xfrm>
            <a:off x="2191948" y="2016299"/>
            <a:ext cx="5245200" cy="36000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xmlns="" id="{53DDDA18-B149-43E2-BEB0-0E1DC57876A7}"/>
              </a:ext>
            </a:extLst>
          </p:cNvPr>
          <p:cNvPicPr>
            <a:picLocks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harpenSoften amount="50000"/>
                    </a14:imgEffect>
                    <a14:imgEffect>
                      <a14:brightnessContrast bright="1000" contrast="-44000"/>
                    </a14:imgEffect>
                  </a14:imgLayer>
                </a14:imgProps>
              </a:ext>
            </a:extLst>
          </a:blip>
          <a:srcRect l="3818" t="30242" b="12241"/>
          <a:stretch/>
        </p:blipFill>
        <p:spPr>
          <a:xfrm>
            <a:off x="7457202" y="2016299"/>
            <a:ext cx="5032800" cy="3600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xmlns="" id="{54B96457-07EC-471A-AB5E-DF5277A9FB49}"/>
              </a:ext>
            </a:extLst>
          </p:cNvPr>
          <p:cNvPicPr>
            <a:picLocks/>
          </p:cNvPicPr>
          <p:nvPr/>
        </p:nvPicPr>
        <p:blipFill rotWithShape="1"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harpenSoften amount="50000"/>
                    </a14:imgEffect>
                    <a14:imgEffect>
                      <a14:brightnessContrast bright="-20000" contrast="-20000"/>
                    </a14:imgEffect>
                  </a14:imgLayer>
                </a14:imgProps>
              </a:ext>
            </a:extLst>
          </a:blip>
          <a:srcRect t="-1" r="3728" b="5153"/>
          <a:stretch/>
        </p:blipFill>
        <p:spPr>
          <a:xfrm>
            <a:off x="2187189" y="1435028"/>
            <a:ext cx="5245200" cy="360000"/>
          </a:xfrm>
          <a:prstGeom prst="rect">
            <a:avLst/>
          </a:prstGeom>
        </p:spPr>
      </p:pic>
      <p:sp>
        <p:nvSpPr>
          <p:cNvPr id="38" name="TextBox 6">
            <a:extLst>
              <a:ext uri="{FF2B5EF4-FFF2-40B4-BE49-F238E27FC236}">
                <a16:creationId xmlns:a16="http://schemas.microsoft.com/office/drawing/2014/main" xmlns="" id="{CC02B728-E4C7-B44D-8E77-BF2DB486A15C}"/>
              </a:ext>
            </a:extLst>
          </p:cNvPr>
          <p:cNvSpPr txBox="1"/>
          <p:nvPr/>
        </p:nvSpPr>
        <p:spPr>
          <a:xfrm>
            <a:off x="670209" y="5524946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6">
            <a:extLst>
              <a:ext uri="{FF2B5EF4-FFF2-40B4-BE49-F238E27FC236}">
                <a16:creationId xmlns:a16="http://schemas.microsoft.com/office/drawing/2014/main" xmlns="" id="{969CF374-5D7F-634B-80EF-BB599CB39A7C}"/>
              </a:ext>
            </a:extLst>
          </p:cNvPr>
          <p:cNvSpPr txBox="1"/>
          <p:nvPr/>
        </p:nvSpPr>
        <p:spPr>
          <a:xfrm>
            <a:off x="670209" y="792163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6">
            <a:extLst>
              <a:ext uri="{FF2B5EF4-FFF2-40B4-BE49-F238E27FC236}">
                <a16:creationId xmlns:a16="http://schemas.microsoft.com/office/drawing/2014/main" xmlns="" id="{7A4147F3-1674-FF42-A540-48EEAFFBAE27}"/>
              </a:ext>
            </a:extLst>
          </p:cNvPr>
          <p:cNvSpPr txBox="1"/>
          <p:nvPr/>
        </p:nvSpPr>
        <p:spPr>
          <a:xfrm>
            <a:off x="670209" y="1780530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6">
            <a:extLst>
              <a:ext uri="{FF2B5EF4-FFF2-40B4-BE49-F238E27FC236}">
                <a16:creationId xmlns:a16="http://schemas.microsoft.com/office/drawing/2014/main" xmlns="" id="{BDC4BD77-6E78-DE40-B5E7-85D684E92CD3}"/>
              </a:ext>
            </a:extLst>
          </p:cNvPr>
          <p:cNvSpPr txBox="1"/>
          <p:nvPr/>
        </p:nvSpPr>
        <p:spPr>
          <a:xfrm>
            <a:off x="670209" y="2690792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6">
            <a:extLst>
              <a:ext uri="{FF2B5EF4-FFF2-40B4-BE49-F238E27FC236}">
                <a16:creationId xmlns:a16="http://schemas.microsoft.com/office/drawing/2014/main" xmlns="" id="{6E0CF6DB-154B-2649-9453-47E17D4A9AD4}"/>
              </a:ext>
            </a:extLst>
          </p:cNvPr>
          <p:cNvSpPr txBox="1"/>
          <p:nvPr/>
        </p:nvSpPr>
        <p:spPr>
          <a:xfrm>
            <a:off x="670209" y="3816499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9">
            <a:extLst>
              <a:ext uri="{FF2B5EF4-FFF2-40B4-BE49-F238E27FC236}">
                <a16:creationId xmlns:a16="http://schemas.microsoft.com/office/drawing/2014/main" xmlns="" id="{4EA665DD-CFD3-A941-A230-30A6EEF949CE}"/>
              </a:ext>
            </a:extLst>
          </p:cNvPr>
          <p:cNvSpPr txBox="1"/>
          <p:nvPr/>
        </p:nvSpPr>
        <p:spPr>
          <a:xfrm>
            <a:off x="952159" y="6255028"/>
            <a:ext cx="1251980" cy="441791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Pid3-F/N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charset="0"/>
              </a:rPr>
              <a:t>C2209T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(216/145 bp)</a:t>
            </a:r>
          </a:p>
        </p:txBody>
      </p:sp>
      <p:sp>
        <p:nvSpPr>
          <p:cNvPr id="47" name="TextBox 13">
            <a:extLst>
              <a:ext uri="{FF2B5EF4-FFF2-40B4-BE49-F238E27FC236}">
                <a16:creationId xmlns:a16="http://schemas.microsoft.com/office/drawing/2014/main" xmlns="" id="{B4941C16-5CFE-2943-9CCA-D4CD2474A000}"/>
              </a:ext>
            </a:extLst>
          </p:cNvPr>
          <p:cNvSpPr txBox="1"/>
          <p:nvPr/>
        </p:nvSpPr>
        <p:spPr>
          <a:xfrm>
            <a:off x="1015744" y="5851081"/>
            <a:ext cx="1188395" cy="440055"/>
          </a:xfrm>
          <a:prstGeom prst="rect">
            <a:avLst/>
          </a:prstGeom>
          <a:noFill/>
        </p:spPr>
        <p:txBody>
          <a:bodyPr wrap="square" lIns="102237" tIns="51119" rIns="102237" bIns="51119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Pid3-F/N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charset="0"/>
              </a:rPr>
              <a:t>G2009A</a:t>
            </a:r>
          </a:p>
          <a:p>
            <a:pPr algn="r"/>
            <a:r>
              <a:rPr lang="en-US" altLang="zh-CN" sz="1100">
                <a:latin typeface="Palatino Linotype" panose="02040502050505030304" pitchFamily="18" charset="0"/>
                <a:cs typeface="Times New Roman" panose="02020603050405020304" charset="0"/>
              </a:rPr>
              <a:t>(138/104 </a:t>
            </a:r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charset="0"/>
              </a:rPr>
              <a:t>bp)</a:t>
            </a:r>
          </a:p>
        </p:txBody>
      </p:sp>
      <p:graphicFrame>
        <p:nvGraphicFramePr>
          <p:cNvPr id="36" name="表格 35">
            <a:extLst>
              <a:ext uri="{FF2B5EF4-FFF2-40B4-BE49-F238E27FC236}">
                <a16:creationId xmlns:a16="http://schemas.microsoft.com/office/drawing/2014/main" xmlns="" id="{9DD9446A-E00F-414E-858D-4C64A16933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5959920"/>
              </p:ext>
            </p:extLst>
          </p:nvPr>
        </p:nvGraphicFramePr>
        <p:xfrm>
          <a:off x="2168743" y="5083747"/>
          <a:ext cx="7011883" cy="67296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0055">
                  <a:extLst>
                    <a:ext uri="{9D8B030D-6E8A-4147-A177-3AD203B41FA5}">
                      <a16:colId xmlns:a16="http://schemas.microsoft.com/office/drawing/2014/main" xmlns="" val="2143522951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1553303557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334457693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148603736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8792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8423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184237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187926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187926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5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6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7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8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29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30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31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32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33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34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35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36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0037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1578323557"/>
                    </a:ext>
                  </a:extLst>
                </a:gridCol>
                <a:gridCol w="187926">
                  <a:extLst>
                    <a:ext uri="{9D8B030D-6E8A-4147-A177-3AD203B41FA5}">
                      <a16:colId xmlns:a16="http://schemas.microsoft.com/office/drawing/2014/main" xmlns="" val="1407579163"/>
                    </a:ext>
                  </a:extLst>
                </a:gridCol>
                <a:gridCol w="190055">
                  <a:extLst>
                    <a:ext uri="{9D8B030D-6E8A-4147-A177-3AD203B41FA5}">
                      <a16:colId xmlns:a16="http://schemas.microsoft.com/office/drawing/2014/main" xmlns="" val="2960260079"/>
                    </a:ext>
                  </a:extLst>
                </a:gridCol>
              </a:tblGrid>
              <a:tr h="6729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6</a:t>
                      </a:r>
                      <a:endParaRPr lang="en-US" sz="1200" b="0" i="0" u="none" strike="noStrike" dirty="0">
                        <a:solidFill>
                          <a:srgbClr val="005427"/>
                        </a:solidFill>
                        <a:effectLst/>
                        <a:latin typeface="Palatino Linotype" panose="02040502050505030304" pitchFamily="18" charset="0"/>
                        <a:cs typeface="Times New Roman" pitchFamily="18" charset="0"/>
                      </a:endParaRP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5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6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7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8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9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0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1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2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3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4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5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6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7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8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9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0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1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2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3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4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5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6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7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8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9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30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31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32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4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219C285F-08B4-4BFA-83B1-D89FD388D65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sharpenSoften amount="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1366" r="2019"/>
          <a:stretch/>
        </p:blipFill>
        <p:spPr>
          <a:xfrm>
            <a:off x="2194950" y="5832763"/>
            <a:ext cx="6985686" cy="36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DA0173A2-0B99-4A13-9DAC-114C23C1C3B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sharpenSoften amount="25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r="728"/>
          <a:stretch/>
        </p:blipFill>
        <p:spPr>
          <a:xfrm>
            <a:off x="2194950" y="6239806"/>
            <a:ext cx="6985676" cy="3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5626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418</TotalTime>
  <Words>258</Words>
  <Application>Microsoft Office PowerPoint</Application>
  <PresentationFormat>Custom</PresentationFormat>
  <Paragraphs>1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等线</vt:lpstr>
      <vt:lpstr>等线 Light</vt:lpstr>
      <vt:lpstr>宋体</vt:lpstr>
      <vt:lpstr>Arial</vt:lpstr>
      <vt:lpstr>Calibri</vt:lpstr>
      <vt:lpstr>Calibri Light</vt:lpstr>
      <vt:lpstr>Palatino Linotype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公共</dc:creator>
  <cp:lastModifiedBy>MDPI</cp:lastModifiedBy>
  <cp:revision>2252</cp:revision>
  <cp:lastPrinted>2020-09-01T02:44:44Z</cp:lastPrinted>
  <dcterms:created xsi:type="dcterms:W3CDTF">2018-08-28T01:53:00Z</dcterms:created>
  <dcterms:modified xsi:type="dcterms:W3CDTF">2022-05-17T08:06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698</vt:lpwstr>
  </property>
</Properties>
</file>